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1" r:id="rId1"/>
  </p:sldMasterIdLst>
  <p:notesMasterIdLst>
    <p:notesMasterId r:id="rId3"/>
  </p:notesMasterIdLst>
  <p:sldIdLst>
    <p:sldId id="4837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39"/>
    <p:restoredTop sz="96006" autoAdjust="0"/>
  </p:normalViewPr>
  <p:slideViewPr>
    <p:cSldViewPr snapToGrid="0">
      <p:cViewPr varScale="1">
        <p:scale>
          <a:sx n="78" d="100"/>
          <a:sy n="78" d="100"/>
        </p:scale>
        <p:origin x="32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43CAF7-936F-5F44-9B2B-A9102139FCC4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47640C-96A2-B84B-B71B-2578F2D698B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0476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9750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039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301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210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56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08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189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367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876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025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73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41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8">
            <a:extLst>
              <a:ext uri="{FF2B5EF4-FFF2-40B4-BE49-F238E27FC236}">
                <a16:creationId xmlns:a16="http://schemas.microsoft.com/office/drawing/2014/main" id="{ED325DE1-548B-4D84-46ED-24896B7439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750" y="4953000"/>
            <a:ext cx="2057400" cy="1235894"/>
          </a:xfrm>
          <a:prstGeom prst="rect">
            <a:avLst/>
          </a:prstGeom>
        </p:spPr>
      </p:pic>
      <p:pic>
        <p:nvPicPr>
          <p:cNvPr id="6" name="Picture 7">
            <a:extLst>
              <a:ext uri="{FF2B5EF4-FFF2-40B4-BE49-F238E27FC236}">
                <a16:creationId xmlns:a16="http://schemas.microsoft.com/office/drawing/2014/main" id="{93BA5D9B-5652-7C79-2F30-D0C93A89E1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1370" y="4997493"/>
            <a:ext cx="2057400" cy="1235894"/>
          </a:xfrm>
          <a:prstGeom prst="rect">
            <a:avLst/>
          </a:prstGeom>
        </p:spPr>
      </p:pic>
      <p:pic>
        <p:nvPicPr>
          <p:cNvPr id="7" name="Picture 8">
            <a:extLst>
              <a:ext uri="{FF2B5EF4-FFF2-40B4-BE49-F238E27FC236}">
                <a16:creationId xmlns:a16="http://schemas.microsoft.com/office/drawing/2014/main" id="{D851364C-63D7-BF68-8DCC-B76C4BB16BA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770" y="6584339"/>
            <a:ext cx="2057400" cy="123589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8D8CA08-B297-B1DF-3DEC-F8F1321869C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1370" y="6536566"/>
            <a:ext cx="2057400" cy="1235894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3B22C919-303F-6B28-CB20-2C26F21B61C1}"/>
              </a:ext>
            </a:extLst>
          </p:cNvPr>
          <p:cNvSpPr txBox="1"/>
          <p:nvPr/>
        </p:nvSpPr>
        <p:spPr>
          <a:xfrm>
            <a:off x="0" y="48549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E77C64E2-0865-183C-7025-8746F92BB816}"/>
              </a:ext>
            </a:extLst>
          </p:cNvPr>
          <p:cNvSpPr txBox="1"/>
          <p:nvPr/>
        </p:nvSpPr>
        <p:spPr>
          <a:xfrm>
            <a:off x="156981" y="52100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FE35E474-3D9F-11E7-7CD3-B2E30F3459CB}"/>
              </a:ext>
            </a:extLst>
          </p:cNvPr>
          <p:cNvSpPr txBox="1"/>
          <p:nvPr/>
        </p:nvSpPr>
        <p:spPr>
          <a:xfrm>
            <a:off x="227529" y="456890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61DD715F-F676-D40B-F159-6BF23C534CD5}"/>
              </a:ext>
            </a:extLst>
          </p:cNvPr>
          <p:cNvSpPr txBox="1"/>
          <p:nvPr/>
        </p:nvSpPr>
        <p:spPr>
          <a:xfrm>
            <a:off x="152308" y="7921726"/>
            <a:ext cx="6553382" cy="14487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0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NAseq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alysis from tissue biopsies of 39 advanced urothelial cancers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: 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 difference in the expression of downstream pathway genes was observed between </a:t>
            </a:r>
            <a:r>
              <a:rPr lang="en-US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FR3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driven (n = 15) and non </a:t>
            </a:r>
            <a:r>
              <a:rPr lang="en-US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FR3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driven (n = 24) cases.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: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each FGFR family member, the difference in gene expression between </a:t>
            </a:r>
            <a:r>
              <a:rPr lang="en-US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FR3-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riven and non </a:t>
            </a:r>
            <a:r>
              <a:rPr lang="en-US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FR3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driven urothelial cancers was assessed through the Mann-Whitney U test (</a:t>
            </a:r>
            <a:r>
              <a:rPr lang="en-US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lcoxom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an-sum test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 ** = p &lt; 0.01; **** 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 p &lt; 0.0001; ns: not significant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PM: Transcripts per million. 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25">
            <a:extLst>
              <a:ext uri="{FF2B5EF4-FFF2-40B4-BE49-F238E27FC236}">
                <a16:creationId xmlns:a16="http://schemas.microsoft.com/office/drawing/2014/main" id="{2E0361B9-05A3-42E1-6EC6-EE6BDF428EF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618" y="834185"/>
            <a:ext cx="6110808" cy="3723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29874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8</TotalTime>
  <Words>106</Words>
  <Application>Microsoft Macintosh PowerPoint</Application>
  <PresentationFormat>A4 (21x29,7 cm)</PresentationFormat>
  <Paragraphs>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82</cp:revision>
  <dcterms:created xsi:type="dcterms:W3CDTF">2022-12-10T11:29:14Z</dcterms:created>
  <dcterms:modified xsi:type="dcterms:W3CDTF">2023-04-01T16:45:11Z</dcterms:modified>
</cp:coreProperties>
</file>